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63" autoAdjust="0"/>
    <p:restoredTop sz="94660"/>
  </p:normalViewPr>
  <p:slideViewPr>
    <p:cSldViewPr snapToGrid="0">
      <p:cViewPr varScale="1">
        <p:scale>
          <a:sx n="73" d="100"/>
          <a:sy n="73" d="100"/>
        </p:scale>
        <p:origin x="135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L:\Deema%20USP-B\Jeddah\TBS\Cancer%20cell%20international\back%20up%20and%20experiments\AGRco%20CSCs%20counts%2025042017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$40</c:f>
              <c:strCache>
                <c:ptCount val="1"/>
                <c:pt idx="0">
                  <c:v>Jed_40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B$46:$E$46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.4464285714285714</c:v>
                  </c:pt>
                </c:numCache>
              </c:numRef>
            </c:plus>
            <c:minus>
              <c:numRef>
                <c:f>Sheet1!$B$46:$E$46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.446428571428571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39:$E$39</c:f>
              <c:strCache>
                <c:ptCount val="4"/>
                <c:pt idx="0">
                  <c:v>Nestin+AGR2+</c:v>
                </c:pt>
                <c:pt idx="1">
                  <c:v>CD133+AGR2+</c:v>
                </c:pt>
                <c:pt idx="2">
                  <c:v>Sox2+AGR2+</c:v>
                </c:pt>
                <c:pt idx="3">
                  <c:v>AGR2+ </c:v>
                </c:pt>
              </c:strCache>
            </c:strRef>
          </c:cat>
          <c:val>
            <c:numRef>
              <c:f>Sheet1!$B$40:$E$40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.4464285714285714</c:v>
                </c:pt>
              </c:numCache>
            </c:numRef>
          </c:val>
        </c:ser>
        <c:ser>
          <c:idx val="1"/>
          <c:order val="1"/>
          <c:tx>
            <c:strRef>
              <c:f>Sheet1!$A$41</c:f>
              <c:strCache>
                <c:ptCount val="1"/>
                <c:pt idx="0">
                  <c:v>Jed_62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B$47:$E$47</c:f>
                <c:numCache>
                  <c:formatCode>General</c:formatCode>
                  <c:ptCount val="4"/>
                  <c:pt idx="0">
                    <c:v>0.34332084893882642</c:v>
                  </c:pt>
                  <c:pt idx="1">
                    <c:v>6.2539086929330828E-2</c:v>
                  </c:pt>
                  <c:pt idx="2">
                    <c:v>0</c:v>
                  </c:pt>
                  <c:pt idx="3">
                    <c:v>0.34332084893882642</c:v>
                  </c:pt>
                </c:numCache>
              </c:numRef>
            </c:plus>
            <c:minus>
              <c:numRef>
                <c:f>Sheet1!$B$47:$E$47</c:f>
                <c:numCache>
                  <c:formatCode>General</c:formatCode>
                  <c:ptCount val="4"/>
                  <c:pt idx="0">
                    <c:v>0.34332084893882642</c:v>
                  </c:pt>
                  <c:pt idx="1">
                    <c:v>6.2539086929330828E-2</c:v>
                  </c:pt>
                  <c:pt idx="2">
                    <c:v>0</c:v>
                  </c:pt>
                  <c:pt idx="3">
                    <c:v>0.3433208489388264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39:$E$39</c:f>
              <c:strCache>
                <c:ptCount val="4"/>
                <c:pt idx="0">
                  <c:v>Nestin+AGR2+</c:v>
                </c:pt>
                <c:pt idx="1">
                  <c:v>CD133+AGR2+</c:v>
                </c:pt>
                <c:pt idx="2">
                  <c:v>Sox2+AGR2+</c:v>
                </c:pt>
                <c:pt idx="3">
                  <c:v>AGR2+ </c:v>
                </c:pt>
              </c:strCache>
            </c:strRef>
          </c:cat>
          <c:val>
            <c:numRef>
              <c:f>Sheet1!$B$41:$E$41</c:f>
              <c:numCache>
                <c:formatCode>General</c:formatCode>
                <c:ptCount val="4"/>
                <c:pt idx="0">
                  <c:v>0.38448095071653271</c:v>
                </c:pt>
                <c:pt idx="1">
                  <c:v>7.0101647388713634E-2</c:v>
                </c:pt>
                <c:pt idx="2">
                  <c:v>0</c:v>
                </c:pt>
                <c:pt idx="3">
                  <c:v>0.34332084893882642</c:v>
                </c:pt>
              </c:numCache>
            </c:numRef>
          </c:val>
        </c:ser>
        <c:ser>
          <c:idx val="2"/>
          <c:order val="2"/>
          <c:tx>
            <c:strRef>
              <c:f>Sheet1!$A$42</c:f>
              <c:strCache>
                <c:ptCount val="1"/>
                <c:pt idx="0">
                  <c:v>Jed_49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B$48:$E$48</c:f>
                <c:numCache>
                  <c:formatCode>General</c:formatCode>
                  <c:ptCount val="4"/>
                  <c:pt idx="0">
                    <c:v>2.9620309320048426</c:v>
                  </c:pt>
                  <c:pt idx="1">
                    <c:v>4.3536062248171934</c:v>
                  </c:pt>
                  <c:pt idx="2">
                    <c:v>7.6600327878705174</c:v>
                  </c:pt>
                  <c:pt idx="3">
                    <c:v>10.477191505428619</c:v>
                  </c:pt>
                </c:numCache>
              </c:numRef>
            </c:plus>
            <c:minus>
              <c:numRef>
                <c:f>Sheet1!$B$48:$E$48</c:f>
                <c:numCache>
                  <c:formatCode>General</c:formatCode>
                  <c:ptCount val="4"/>
                  <c:pt idx="0">
                    <c:v>2.9620309320048426</c:v>
                  </c:pt>
                  <c:pt idx="1">
                    <c:v>4.3536062248171934</c:v>
                  </c:pt>
                  <c:pt idx="2">
                    <c:v>7.6600327878705174</c:v>
                  </c:pt>
                  <c:pt idx="3">
                    <c:v>10.47719150542861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39:$E$39</c:f>
              <c:strCache>
                <c:ptCount val="4"/>
                <c:pt idx="0">
                  <c:v>Nestin+AGR2+</c:v>
                </c:pt>
                <c:pt idx="1">
                  <c:v>CD133+AGR2+</c:v>
                </c:pt>
                <c:pt idx="2">
                  <c:v>Sox2+AGR2+</c:v>
                </c:pt>
                <c:pt idx="3">
                  <c:v>AGR2+ </c:v>
                </c:pt>
              </c:strCache>
            </c:strRef>
          </c:cat>
          <c:val>
            <c:numRef>
              <c:f>Sheet1!$B$42:$E$42</c:f>
              <c:numCache>
                <c:formatCode>General</c:formatCode>
                <c:ptCount val="4"/>
                <c:pt idx="0">
                  <c:v>4.3069127759681507</c:v>
                </c:pt>
                <c:pt idx="1">
                  <c:v>4.6770601336302899</c:v>
                </c:pt>
                <c:pt idx="2">
                  <c:v>17.846790890269151</c:v>
                </c:pt>
                <c:pt idx="3">
                  <c:v>24.380600867615243</c:v>
                </c:pt>
              </c:numCache>
            </c:numRef>
          </c:val>
        </c:ser>
        <c:ser>
          <c:idx val="3"/>
          <c:order val="3"/>
          <c:tx>
            <c:strRef>
              <c:f>Sheet1!$A$43</c:f>
              <c:strCache>
                <c:ptCount val="1"/>
                <c:pt idx="0">
                  <c:v>Jed_45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Sheet1!$B$49:$E$49</c:f>
                <c:numCache>
                  <c:formatCode>General</c:formatCode>
                  <c:ptCount val="4"/>
                  <c:pt idx="0">
                    <c:v>3.1167551921563321</c:v>
                  </c:pt>
                  <c:pt idx="1">
                    <c:v>7.7717501038200441</c:v>
                  </c:pt>
                  <c:pt idx="2">
                    <c:v>1.9894207439667602</c:v>
                  </c:pt>
                  <c:pt idx="3">
                    <c:v>4.9523233988250528</c:v>
                  </c:pt>
                </c:numCache>
              </c:numRef>
            </c:plus>
            <c:minus>
              <c:numRef>
                <c:f>Sheet1!$B$49:$E$49</c:f>
                <c:numCache>
                  <c:formatCode>General</c:formatCode>
                  <c:ptCount val="4"/>
                  <c:pt idx="0">
                    <c:v>3.1167551921563321</c:v>
                  </c:pt>
                  <c:pt idx="1">
                    <c:v>7.7717501038200441</c:v>
                  </c:pt>
                  <c:pt idx="2">
                    <c:v>1.9894207439667602</c:v>
                  </c:pt>
                  <c:pt idx="3">
                    <c:v>4.952323398825052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39:$E$39</c:f>
              <c:strCache>
                <c:ptCount val="4"/>
                <c:pt idx="0">
                  <c:v>Nestin+AGR2+</c:v>
                </c:pt>
                <c:pt idx="1">
                  <c:v>CD133+AGR2+</c:v>
                </c:pt>
                <c:pt idx="2">
                  <c:v>Sox2+AGR2+</c:v>
                </c:pt>
                <c:pt idx="3">
                  <c:v>AGR2+ </c:v>
                </c:pt>
              </c:strCache>
            </c:strRef>
          </c:cat>
          <c:val>
            <c:numRef>
              <c:f>Sheet1!$B$43:$E$43</c:f>
              <c:numCache>
                <c:formatCode>General</c:formatCode>
                <c:ptCount val="4"/>
                <c:pt idx="0">
                  <c:v>69.461358313817328</c:v>
                </c:pt>
                <c:pt idx="1">
                  <c:v>47.726288436552622</c:v>
                </c:pt>
                <c:pt idx="2">
                  <c:v>9.8834498834498845</c:v>
                </c:pt>
                <c:pt idx="3">
                  <c:v>75.02935178561807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70849424"/>
        <c:axId val="370850600"/>
      </c:barChart>
      <c:catAx>
        <c:axId val="3708494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70850600"/>
        <c:crosses val="autoZero"/>
        <c:auto val="1"/>
        <c:lblAlgn val="ctr"/>
        <c:lblOffset val="100"/>
        <c:noMultiLvlLbl val="0"/>
      </c:catAx>
      <c:valAx>
        <c:axId val="370850600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/>
                  <a:t>Percentage of Cells %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708494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A8DDC-7D31-4473-B498-E8812C16225A}" type="datetimeFigureOut">
              <a:rPr lang="en-GB" smtClean="0"/>
              <a:t>04/05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4D698-C5BB-41EF-8822-38FDB17B67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5571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A8DDC-7D31-4473-B498-E8812C16225A}" type="datetimeFigureOut">
              <a:rPr lang="en-GB" smtClean="0"/>
              <a:t>04/05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4D698-C5BB-41EF-8822-38FDB17B67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61411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A8DDC-7D31-4473-B498-E8812C16225A}" type="datetimeFigureOut">
              <a:rPr lang="en-GB" smtClean="0"/>
              <a:t>04/05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4D698-C5BB-41EF-8822-38FDB17B67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50384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A8DDC-7D31-4473-B498-E8812C16225A}" type="datetimeFigureOut">
              <a:rPr lang="en-GB" smtClean="0"/>
              <a:t>04/05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4D698-C5BB-41EF-8822-38FDB17B67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52414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A8DDC-7D31-4473-B498-E8812C16225A}" type="datetimeFigureOut">
              <a:rPr lang="en-GB" smtClean="0"/>
              <a:t>04/05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4D698-C5BB-41EF-8822-38FDB17B67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74809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A8DDC-7D31-4473-B498-E8812C16225A}" type="datetimeFigureOut">
              <a:rPr lang="en-GB" smtClean="0"/>
              <a:t>04/05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4D698-C5BB-41EF-8822-38FDB17B67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68656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A8DDC-7D31-4473-B498-E8812C16225A}" type="datetimeFigureOut">
              <a:rPr lang="en-GB" smtClean="0"/>
              <a:t>04/05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4D698-C5BB-41EF-8822-38FDB17B67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39763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A8DDC-7D31-4473-B498-E8812C16225A}" type="datetimeFigureOut">
              <a:rPr lang="en-GB" smtClean="0"/>
              <a:t>04/05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4D698-C5BB-41EF-8822-38FDB17B67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73836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A8DDC-7D31-4473-B498-E8812C16225A}" type="datetimeFigureOut">
              <a:rPr lang="en-GB" smtClean="0"/>
              <a:t>04/05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4D698-C5BB-41EF-8822-38FDB17B67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7598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A8DDC-7D31-4473-B498-E8812C16225A}" type="datetimeFigureOut">
              <a:rPr lang="en-GB" smtClean="0"/>
              <a:t>04/05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4D698-C5BB-41EF-8822-38FDB17B67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90392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A8DDC-7D31-4473-B498-E8812C16225A}" type="datetimeFigureOut">
              <a:rPr lang="en-GB" smtClean="0"/>
              <a:t>04/05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4D698-C5BB-41EF-8822-38FDB17B67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78133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2A8DDC-7D31-4473-B498-E8812C16225A}" type="datetimeFigureOut">
              <a:rPr lang="en-GB" smtClean="0"/>
              <a:t>04/05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C4D698-C5BB-41EF-8822-38FDB17B672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44785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18" Type="http://schemas.openxmlformats.org/officeDocument/2006/relationships/chart" Target="../charts/chart1.xml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-19133" y="228600"/>
            <a:ext cx="6894314" cy="9655456"/>
            <a:chOff x="-19133" y="228600"/>
            <a:chExt cx="6894314" cy="9655456"/>
          </a:xfrm>
        </p:grpSpPr>
        <p:sp>
          <p:nvSpPr>
            <p:cNvPr id="7" name="TextBox 27"/>
            <p:cNvSpPr txBox="1">
              <a:spLocks noChangeArrowheads="1"/>
            </p:cNvSpPr>
            <p:nvPr/>
          </p:nvSpPr>
          <p:spPr bwMode="auto">
            <a:xfrm>
              <a:off x="2284258" y="433320"/>
              <a:ext cx="983976" cy="2308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en-US" sz="1400" dirty="0" smtClean="0">
                  <a:latin typeface="Times New Roman" pitchFamily="18" charset="0"/>
                  <a:cs typeface="Times New Roman" pitchFamily="18" charset="0"/>
                </a:rPr>
                <a:t>Jed62_MN</a:t>
              </a:r>
              <a:endParaRPr lang="en-GB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66530" y="4479980"/>
              <a:ext cx="1602000" cy="1201500"/>
            </a:xfrm>
            <a:prstGeom prst="rect">
              <a:avLst/>
            </a:prstGeom>
          </p:spPr>
        </p:pic>
        <p:sp>
          <p:nvSpPr>
            <p:cNvPr id="6" name="TextBox 5"/>
            <p:cNvSpPr txBox="1">
              <a:spLocks noChangeArrowheads="1"/>
            </p:cNvSpPr>
            <p:nvPr/>
          </p:nvSpPr>
          <p:spPr bwMode="auto">
            <a:xfrm>
              <a:off x="5452256" y="433320"/>
              <a:ext cx="1157065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en-US" sz="1400" dirty="0" smtClean="0">
                  <a:latin typeface="Times New Roman" pitchFamily="18" charset="0"/>
                  <a:cs typeface="Times New Roman" pitchFamily="18" charset="0"/>
                </a:rPr>
                <a:t>Jed45_MN</a:t>
              </a:r>
              <a:endParaRPr lang="en-GB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" name="TextBox 18"/>
            <p:cNvSpPr txBox="1">
              <a:spLocks noChangeArrowheads="1"/>
            </p:cNvSpPr>
            <p:nvPr/>
          </p:nvSpPr>
          <p:spPr bwMode="auto">
            <a:xfrm rot="16200000">
              <a:off x="-311796" y="5005782"/>
              <a:ext cx="939681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en-US" sz="1200" dirty="0" smtClean="0">
                  <a:solidFill>
                    <a:srgbClr val="00B050"/>
                  </a:solidFill>
                  <a:latin typeface="Times New Roman" pitchFamily="18" charset="0"/>
                  <a:cs typeface="Times New Roman" pitchFamily="18" charset="0"/>
                </a:rPr>
                <a:t>Sox2</a:t>
              </a:r>
              <a:r>
                <a:rPr lang="en-US" altLang="en-US" sz="120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AGR2</a:t>
              </a:r>
              <a:r>
                <a:rPr lang="en-US" altLang="en-US" sz="12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endParaRPr lang="en-GB" altLang="en-US" sz="1200" dirty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" name="TextBox 8"/>
            <p:cNvSpPr txBox="1">
              <a:spLocks noChangeArrowheads="1"/>
            </p:cNvSpPr>
            <p:nvPr/>
          </p:nvSpPr>
          <p:spPr bwMode="auto">
            <a:xfrm>
              <a:off x="-19133" y="228600"/>
              <a:ext cx="263129" cy="2774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b="1" dirty="0">
                  <a:latin typeface="Times New Roman" pitchFamily="18" charset="0"/>
                  <a:cs typeface="Times New Roman" pitchFamily="18" charset="0"/>
                </a:rPr>
                <a:t>A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 rot="16200000">
              <a:off x="-359733" y="2533855"/>
              <a:ext cx="10355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solidFill>
                    <a:srgbClr val="00B050"/>
                  </a:solidFill>
                  <a:latin typeface="Times New Roman" pitchFamily="18" charset="0"/>
                  <a:cs typeface="Times New Roman" pitchFamily="18" charset="0"/>
                </a:rPr>
                <a:t>Nestin</a:t>
              </a:r>
              <a:r>
                <a:rPr lang="en-US" sz="120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AGR2</a:t>
              </a:r>
              <a:endParaRPr lang="en-US" sz="1200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 rot="16200000">
              <a:off x="-402423" y="3795744"/>
              <a:ext cx="11209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solidFill>
                    <a:srgbClr val="00B050"/>
                  </a:solidFill>
                  <a:latin typeface="Times New Roman" pitchFamily="18" charset="0"/>
                  <a:cs typeface="Times New Roman" pitchFamily="18" charset="0"/>
                </a:rPr>
                <a:t>CD133</a:t>
              </a:r>
              <a:r>
                <a:rPr lang="en-US" sz="120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AGR2</a:t>
              </a:r>
              <a:endParaRPr lang="en-US" sz="1200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-451258" y="1243631"/>
              <a:ext cx="12186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Negative control</a:t>
              </a:r>
              <a:endParaRPr lang="en-GB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" name="TextBox 15"/>
            <p:cNvSpPr txBox="1">
              <a:spLocks noChangeArrowheads="1"/>
            </p:cNvSpPr>
            <p:nvPr/>
          </p:nvSpPr>
          <p:spPr bwMode="auto">
            <a:xfrm>
              <a:off x="557369" y="433320"/>
              <a:ext cx="1157065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en-US" sz="1400" dirty="0" smtClean="0">
                  <a:latin typeface="Times New Roman" pitchFamily="18" charset="0"/>
                  <a:cs typeface="Times New Roman" pitchFamily="18" charset="0"/>
                </a:rPr>
                <a:t>Jed40_MN</a:t>
              </a:r>
              <a:endParaRPr lang="en-GB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" name="TextBox 16"/>
            <p:cNvSpPr txBox="1">
              <a:spLocks noChangeArrowheads="1"/>
            </p:cNvSpPr>
            <p:nvPr/>
          </p:nvSpPr>
          <p:spPr bwMode="auto">
            <a:xfrm>
              <a:off x="3814710" y="433320"/>
              <a:ext cx="1157065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en-US" sz="1400" dirty="0" smtClean="0">
                  <a:latin typeface="Times New Roman" pitchFamily="18" charset="0"/>
                  <a:cs typeface="Times New Roman" pitchFamily="18" charset="0"/>
                </a:rPr>
                <a:t>Jed49_MN</a:t>
              </a:r>
              <a:endParaRPr lang="en-GB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29788" y="3234930"/>
              <a:ext cx="1602000" cy="1201500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29788" y="1989880"/>
              <a:ext cx="1602000" cy="1201500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29788" y="4479980"/>
              <a:ext cx="1602000" cy="1201500"/>
            </a:xfrm>
            <a:prstGeom prst="rect">
              <a:avLst/>
            </a:prstGeom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29788" y="744830"/>
              <a:ext cx="1602000" cy="1201500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98159" y="744830"/>
              <a:ext cx="1602000" cy="1201500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98159" y="1989880"/>
              <a:ext cx="1602000" cy="1201500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98159" y="3234930"/>
              <a:ext cx="1602000" cy="1201500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98159" y="4479980"/>
              <a:ext cx="1602000" cy="1201500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4901" y="3234930"/>
              <a:ext cx="1602000" cy="1201500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4901" y="1989880"/>
              <a:ext cx="1602000" cy="1201500"/>
            </a:xfrm>
            <a:prstGeom prst="rect">
              <a:avLst/>
            </a:prstGeom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4901" y="4479980"/>
              <a:ext cx="1602000" cy="1201500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4901" y="744830"/>
              <a:ext cx="1602000" cy="1201500"/>
            </a:xfrm>
            <a:prstGeom prst="rect">
              <a:avLst/>
            </a:prstGeom>
          </p:spPr>
        </p:pic>
        <p:sp>
          <p:nvSpPr>
            <p:cNvPr id="34" name="TextBox 36"/>
            <p:cNvSpPr txBox="1">
              <a:spLocks noChangeArrowheads="1"/>
            </p:cNvSpPr>
            <p:nvPr/>
          </p:nvSpPr>
          <p:spPr bwMode="auto">
            <a:xfrm>
              <a:off x="6085446" y="5725030"/>
              <a:ext cx="523875" cy="23098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100µm</a:t>
              </a:r>
              <a:endParaRPr lang="en-GB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35" name="Straight Connector 34"/>
            <p:cNvCxnSpPr/>
            <p:nvPr/>
          </p:nvCxnSpPr>
          <p:spPr>
            <a:xfrm>
              <a:off x="6255885" y="6020688"/>
              <a:ext cx="265001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66530" y="743930"/>
              <a:ext cx="1603200" cy="1202400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66530" y="1988980"/>
              <a:ext cx="1603200" cy="1202400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66530" y="3234930"/>
              <a:ext cx="1603200" cy="1202400"/>
            </a:xfrm>
            <a:prstGeom prst="rect">
              <a:avLst/>
            </a:prstGeom>
          </p:spPr>
        </p:pic>
        <p:sp>
          <p:nvSpPr>
            <p:cNvPr id="38" name="TextBox 19"/>
            <p:cNvSpPr txBox="1">
              <a:spLocks noChangeArrowheads="1"/>
            </p:cNvSpPr>
            <p:nvPr/>
          </p:nvSpPr>
          <p:spPr bwMode="auto">
            <a:xfrm>
              <a:off x="-19133" y="5983224"/>
              <a:ext cx="263129" cy="2774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b="1" dirty="0">
                  <a:latin typeface="Times New Roman" pitchFamily="18" charset="0"/>
                  <a:cs typeface="Times New Roman" pitchFamily="18" charset="0"/>
                </a:rPr>
                <a:t>B</a:t>
              </a:r>
            </a:p>
          </p:txBody>
        </p:sp>
        <p:graphicFrame>
          <p:nvGraphicFramePr>
            <p:cNvPr id="32" name="Chart 3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65248561"/>
                </p:ext>
              </p:extLst>
            </p:nvPr>
          </p:nvGraphicFramePr>
          <p:xfrm>
            <a:off x="112431" y="5999562"/>
            <a:ext cx="6762750" cy="388449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8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27897782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9</TotalTime>
  <Words>16</Words>
  <Application>Microsoft Office PowerPoint</Application>
  <PresentationFormat>A4 Paper (210x297 mm)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ديمه محمد  حسين</dc:creator>
  <cp:lastModifiedBy>DEEMA MOHAMAD *************** HUSSAIN</cp:lastModifiedBy>
  <cp:revision>11</cp:revision>
  <dcterms:created xsi:type="dcterms:W3CDTF">2017-04-06T09:51:38Z</dcterms:created>
  <dcterms:modified xsi:type="dcterms:W3CDTF">2017-05-04T13:35:11Z</dcterms:modified>
</cp:coreProperties>
</file>